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9" d="100"/>
          <a:sy n="69" d="100"/>
        </p:scale>
        <p:origin x="52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5EFD-8FAA-4EDE-BF3D-B5D90AA3ADDE}" type="datetimeFigureOut">
              <a:rPr lang="en-US" smtClean="0"/>
              <a:t>9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2D31-E61F-4DE7-A5A3-A27914298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8515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5EFD-8FAA-4EDE-BF3D-B5D90AA3ADDE}" type="datetimeFigureOut">
              <a:rPr lang="en-US" smtClean="0"/>
              <a:t>9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2D31-E61F-4DE7-A5A3-A27914298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783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5EFD-8FAA-4EDE-BF3D-B5D90AA3ADDE}" type="datetimeFigureOut">
              <a:rPr lang="en-US" smtClean="0"/>
              <a:t>9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2D31-E61F-4DE7-A5A3-A27914298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2431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5EFD-8FAA-4EDE-BF3D-B5D90AA3ADDE}" type="datetimeFigureOut">
              <a:rPr lang="en-US" smtClean="0"/>
              <a:t>9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2D31-E61F-4DE7-A5A3-A27914298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4078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5EFD-8FAA-4EDE-BF3D-B5D90AA3ADDE}" type="datetimeFigureOut">
              <a:rPr lang="en-US" smtClean="0"/>
              <a:t>9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2D31-E61F-4DE7-A5A3-A27914298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4831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5EFD-8FAA-4EDE-BF3D-B5D90AA3ADDE}" type="datetimeFigureOut">
              <a:rPr lang="en-US" smtClean="0"/>
              <a:t>9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2D31-E61F-4DE7-A5A3-A27914298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49563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5EFD-8FAA-4EDE-BF3D-B5D90AA3ADDE}" type="datetimeFigureOut">
              <a:rPr lang="en-US" smtClean="0"/>
              <a:t>9/1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2D31-E61F-4DE7-A5A3-A27914298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3702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5EFD-8FAA-4EDE-BF3D-B5D90AA3ADDE}" type="datetimeFigureOut">
              <a:rPr lang="en-US" smtClean="0"/>
              <a:t>9/1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2D31-E61F-4DE7-A5A3-A27914298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80540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5EFD-8FAA-4EDE-BF3D-B5D90AA3ADDE}" type="datetimeFigureOut">
              <a:rPr lang="en-US" smtClean="0"/>
              <a:t>9/1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2D31-E61F-4DE7-A5A3-A27914298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9219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5EFD-8FAA-4EDE-BF3D-B5D90AA3ADDE}" type="datetimeFigureOut">
              <a:rPr lang="en-US" smtClean="0"/>
              <a:t>9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2D31-E61F-4DE7-A5A3-A27914298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062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5EFD-8FAA-4EDE-BF3D-B5D90AA3ADDE}" type="datetimeFigureOut">
              <a:rPr lang="en-US" smtClean="0"/>
              <a:t>9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2D31-E61F-4DE7-A5A3-A27914298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5035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6A5EFD-8FAA-4EDE-BF3D-B5D90AA3ADDE}" type="datetimeFigureOut">
              <a:rPr lang="en-US" smtClean="0"/>
              <a:t>9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F42D31-E61F-4DE7-A5A3-A27914298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864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27250346"/>
              </p:ext>
            </p:extLst>
          </p:nvPr>
        </p:nvGraphicFramePr>
        <p:xfrm>
          <a:off x="687572" y="435934"/>
          <a:ext cx="8817939" cy="194620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66530">
                  <a:extLst>
                    <a:ext uri="{9D8B030D-6E8A-4147-A177-3AD203B41FA5}">
                      <a16:colId xmlns:a16="http://schemas.microsoft.com/office/drawing/2014/main" val="1201226810"/>
                    </a:ext>
                  </a:extLst>
                </a:gridCol>
                <a:gridCol w="393405">
                  <a:extLst>
                    <a:ext uri="{9D8B030D-6E8A-4147-A177-3AD203B41FA5}">
                      <a16:colId xmlns:a16="http://schemas.microsoft.com/office/drawing/2014/main" val="70553938"/>
                    </a:ext>
                  </a:extLst>
                </a:gridCol>
                <a:gridCol w="685446">
                  <a:extLst>
                    <a:ext uri="{9D8B030D-6E8A-4147-A177-3AD203B41FA5}">
                      <a16:colId xmlns:a16="http://schemas.microsoft.com/office/drawing/2014/main" val="3391346591"/>
                    </a:ext>
                  </a:extLst>
                </a:gridCol>
                <a:gridCol w="881794">
                  <a:extLst>
                    <a:ext uri="{9D8B030D-6E8A-4147-A177-3AD203B41FA5}">
                      <a16:colId xmlns:a16="http://schemas.microsoft.com/office/drawing/2014/main" val="3695976705"/>
                    </a:ext>
                  </a:extLst>
                </a:gridCol>
                <a:gridCol w="881794">
                  <a:extLst>
                    <a:ext uri="{9D8B030D-6E8A-4147-A177-3AD203B41FA5}">
                      <a16:colId xmlns:a16="http://schemas.microsoft.com/office/drawing/2014/main" val="2724870775"/>
                    </a:ext>
                  </a:extLst>
                </a:gridCol>
                <a:gridCol w="881794">
                  <a:extLst>
                    <a:ext uri="{9D8B030D-6E8A-4147-A177-3AD203B41FA5}">
                      <a16:colId xmlns:a16="http://schemas.microsoft.com/office/drawing/2014/main" val="2627787393"/>
                    </a:ext>
                  </a:extLst>
                </a:gridCol>
                <a:gridCol w="881794">
                  <a:extLst>
                    <a:ext uri="{9D8B030D-6E8A-4147-A177-3AD203B41FA5}">
                      <a16:colId xmlns:a16="http://schemas.microsoft.com/office/drawing/2014/main" val="2036695928"/>
                    </a:ext>
                  </a:extLst>
                </a:gridCol>
                <a:gridCol w="881794">
                  <a:extLst>
                    <a:ext uri="{9D8B030D-6E8A-4147-A177-3AD203B41FA5}">
                      <a16:colId xmlns:a16="http://schemas.microsoft.com/office/drawing/2014/main" val="1324826799"/>
                    </a:ext>
                  </a:extLst>
                </a:gridCol>
                <a:gridCol w="881794">
                  <a:extLst>
                    <a:ext uri="{9D8B030D-6E8A-4147-A177-3AD203B41FA5}">
                      <a16:colId xmlns:a16="http://schemas.microsoft.com/office/drawing/2014/main" val="1048936836"/>
                    </a:ext>
                  </a:extLst>
                </a:gridCol>
                <a:gridCol w="881794">
                  <a:extLst>
                    <a:ext uri="{9D8B030D-6E8A-4147-A177-3AD203B41FA5}">
                      <a16:colId xmlns:a16="http://schemas.microsoft.com/office/drawing/2014/main" val="2588259521"/>
                    </a:ext>
                  </a:extLst>
                </a:gridCol>
              </a:tblGrid>
              <a:tr h="41409"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ect2</a:t>
                      </a:r>
                      <a:endParaRPr lang="en-US" sz="11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ect2</a:t>
                      </a:r>
                      <a:endParaRPr lang="en-US" sz="11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io p/total</a:t>
                      </a:r>
                      <a:endParaRPr lang="en-US" sz="1100" b="1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627834"/>
                  </a:ext>
                </a:extLst>
              </a:tr>
              <a:tr h="21288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annel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n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nd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olume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ne %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olume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48653843"/>
                  </a:ext>
                </a:extLst>
              </a:tr>
              <a:tr h="38531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emiluminescence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549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433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232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0227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64629759"/>
                  </a:ext>
                </a:extLst>
              </a:tr>
              <a:tr h="57265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emiluminescence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-empty vector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182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835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35471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94929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8079734"/>
                  </a:ext>
                </a:extLst>
              </a:tr>
              <a:tr h="38531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emiluminescence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LC-FL1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868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153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124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1055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37122018"/>
                  </a:ext>
                </a:extLst>
              </a:tr>
              <a:tr h="212881"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75696277"/>
                  </a:ext>
                </a:extLst>
              </a:tr>
            </a:tbl>
          </a:graphicData>
        </a:graphic>
      </p:graphicFrame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/>
          <a:srcRect l="4619" t="35174" r="70485" b="38309"/>
          <a:stretch/>
        </p:blipFill>
        <p:spPr>
          <a:xfrm>
            <a:off x="1499749" y="2383698"/>
            <a:ext cx="6176958" cy="3576133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838893" y="6097142"/>
            <a:ext cx="668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549</a:t>
            </a:r>
            <a:endParaRPr lang="en-US" dirty="0"/>
          </a:p>
        </p:txBody>
      </p:sp>
      <p:sp>
        <p:nvSpPr>
          <p:cNvPr id="9" name="Rectangle 8"/>
          <p:cNvSpPr/>
          <p:nvPr/>
        </p:nvSpPr>
        <p:spPr>
          <a:xfrm>
            <a:off x="4503168" y="6189553"/>
            <a:ext cx="85016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control</a:t>
            </a:r>
            <a:endParaRPr lang="en-US" dirty="0"/>
          </a:p>
        </p:txBody>
      </p:sp>
      <p:sp>
        <p:nvSpPr>
          <p:cNvPr id="10" name="Rectangle 9"/>
          <p:cNvSpPr/>
          <p:nvPr/>
        </p:nvSpPr>
        <p:spPr>
          <a:xfrm>
            <a:off x="6348839" y="6189553"/>
            <a:ext cx="93718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DLC1-FL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8904606" y="5959831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6 Figu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6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2</TotalTime>
  <Words>42</Words>
  <Application>Microsoft Office PowerPoint</Application>
  <PresentationFormat>Widescreen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eth, Edyta</dc:creator>
  <cp:lastModifiedBy>Polar, Yesim</cp:lastModifiedBy>
  <cp:revision>10</cp:revision>
  <dcterms:created xsi:type="dcterms:W3CDTF">2015-10-07T13:20:32Z</dcterms:created>
  <dcterms:modified xsi:type="dcterms:W3CDTF">2018-09-16T19:11:52Z</dcterms:modified>
</cp:coreProperties>
</file>